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84" r:id="rId2"/>
    <p:sldId id="401" r:id="rId3"/>
  </p:sldIdLst>
  <p:sldSz cx="12192000" cy="6858000"/>
  <p:notesSz cx="6797675" cy="9928225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02" autoAdjust="0"/>
    <p:restoredTop sz="93826" autoAdjust="0"/>
  </p:normalViewPr>
  <p:slideViewPr>
    <p:cSldViewPr snapToGrid="0">
      <p:cViewPr varScale="1">
        <p:scale>
          <a:sx n="79" d="100"/>
          <a:sy n="79" d="100"/>
        </p:scale>
        <p:origin x="621" y="59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8E0047-58E3-4469-A8A0-65FC82E824C4}" type="datetimeFigureOut">
              <a:rPr lang="en-US" smtClean="0"/>
              <a:t>7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3234A-7E1D-4B5E-8441-DD84CFD70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05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218EE724-2B86-4746-AFCB-AE5D0310F954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51275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1DA297A-CCB0-4767-ADE0-0329CBDAD26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579447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78E77EEB-22D1-4609-A977-A7383D1AB5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842542CF-8572-4340-B124-DF429A585A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D8C7FE09-4794-4B32-86E5-F94165786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311C9020-E5D8-4DDF-924A-8EAD1A9E6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91819537-E883-4B3E-A509-FBF8A97AB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88579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6DF1608-45A8-41B3-8C30-297348EF33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6D82EF44-1122-4424-B6F8-5BA389739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746E7FF2-2A5A-49F9-919E-C4405F9D7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D228EEC-1503-417E-8E3C-84E8E7F3A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A7528CE1-CDC0-4B98-941F-93EF459B4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9441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4EF34FCC-CC49-49EB-B66B-DB9096C7ED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86D98C94-E15B-4490-A390-19C0954B5C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03736C04-C259-41FB-A3C7-82C87CB5B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3A77308E-EEAE-4B34-9823-6EB7FAD7C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34B5B23F-529B-4BAA-8517-90D69D15C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2162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DD05F826-E31E-4B71-B0F3-CE997967C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AB39823A-F5EA-4697-B71D-09112C9A1B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6C9817EB-2E20-452E-8089-AC7FE78BF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1370EB35-5423-45A6-BDBF-1FA2E8738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7C1FEB9A-0732-41AB-AACD-A82C28854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608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B44450CC-0881-4CEB-B338-FBA3E782E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F1AAA8A6-33B5-4AF1-8428-7DB9FCDB1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832D01FA-83F7-40C4-8FC3-F0E52F343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1BF84B82-6A11-4081-A479-BB7810812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C858C42-D7EC-437B-80DD-A9A38C77B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16346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A0AF1069-CC98-4766-B3C4-5CA796D040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18C1C0DC-0650-4021-8EC4-84BC1C1866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516D2A10-D5B9-4572-B15B-096141155E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4670FD1B-7448-4AFE-A900-72CAD375C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35EDAE50-53E4-4D95-A787-8592F81D5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4A2C652A-4119-45AB-A626-A6A7220C0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99504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BED6FA72-9F6E-43C9-AFF3-85F864019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8BF6840D-C10E-4012-B1CB-B51951ACA1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C3265F8E-013E-4AD4-956B-B6BE9BA12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1F0FD769-6C40-4513-8086-FD337B14DB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47FCC0EC-C73B-4203-8220-3B643B2ED2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93BA1B70-E06E-403D-B326-9EC2511F3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C87423B7-FA56-422E-A212-4BA0030A7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0AB3F562-349E-497B-9EB4-77C599827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1643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1300172D-92DD-490C-BE6C-D4C710D3D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05221CE2-CE7D-40D9-BD13-9DC18A174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6FED0DB2-F1F3-4CD3-89C6-F4F0AB469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88FC7CC6-52EE-438C-B3D4-D85A3DF6E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17160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BBABFDF1-C4AB-4328-90DA-CE7DB3798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94C427CA-14D0-451C-B9E1-400E73FA4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758545DC-060E-48D8-994E-DDFF56449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90682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5CAFAC1-CFB0-4F8A-9947-0405A21E64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9282F43D-ED1B-410C-B85B-EB8C329A5B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9E4A671E-5C32-4B3F-AB07-9AD4065DAA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335F03D0-1038-4997-AAEF-F08DF4006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91C54736-9584-4DD2-9600-79D83A2B6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5283AFDD-52C8-49D5-97C0-7E88CB358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2445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C6DC7C9A-78BF-4599-8674-C7C548D0C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C8825EE2-1A92-4FFF-8A7B-6BFC4192A8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588BC0B3-6836-4BD9-BDAC-08BACC9708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A3BDA644-530C-4AD5-BADC-65EA4C030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24FA2D0B-936D-40C6-9524-3721C0EA3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782C9706-5ACF-4494-B505-6B5B3EABD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09925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1716C369-00C9-4269-BB35-47D9D75C1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329BB9FC-A103-421A-A1A7-F5359466D0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7960948D-23AD-4FEA-B2EA-55D9B37A93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3F622-EA33-4C0D-8BDF-4A696E26C1A3}" type="datetimeFigureOut">
              <a:rPr lang="he-IL" smtClean="0"/>
              <a:t>י"ח/תמוז/תשע"ט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C18D6522-5D77-4EF7-BBA4-B130055EB1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F99CF99A-CB32-4101-A5F5-1966B5B41D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0423B9-3EDF-454F-B039-9752781C420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8437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מלבן 26">
            <a:extLst>
              <a:ext uri="{FF2B5EF4-FFF2-40B4-BE49-F238E27FC236}">
                <a16:creationId xmlns:a16="http://schemas.microsoft.com/office/drawing/2014/main" id="{5F82AB10-AAC3-4A69-9FD0-AC1206CA7B87}"/>
              </a:ext>
            </a:extLst>
          </p:cNvPr>
          <p:cNvSpPr/>
          <p:nvPr/>
        </p:nvSpPr>
        <p:spPr>
          <a:xfrm>
            <a:off x="443854" y="4979434"/>
            <a:ext cx="999554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2400" b="1" dirty="0"/>
              <a:t>Figure S1: </a:t>
            </a:r>
            <a:r>
              <a:rPr lang="en-US" dirty="0"/>
              <a:t>Relative improvement in </a:t>
            </a:r>
            <a:r>
              <a:rPr lang="en-US" dirty="0" err="1"/>
              <a:t>TNF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secretion by the TIGIT-28 population over that of the control population was calculated as (</a:t>
            </a:r>
            <a:r>
              <a:rPr lang="en-US" dirty="0" err="1"/>
              <a:t>TNF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secretion in TIGIT-28 group-</a:t>
            </a:r>
            <a:r>
              <a:rPr lang="en-US" dirty="0" err="1"/>
              <a:t>TNF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secretion in control group)/</a:t>
            </a:r>
            <a:r>
              <a:rPr lang="en-US" dirty="0" err="1"/>
              <a:t>TNF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secretion in control group*100%. This value was plotted as a function of CD155 expression by the target cells. A significant correlation (R</a:t>
            </a:r>
            <a:r>
              <a:rPr lang="en-US" baseline="30000" dirty="0"/>
              <a:t>2</a:t>
            </a:r>
            <a:r>
              <a:rPr lang="en-US" dirty="0"/>
              <a:t>=0.8923 using linear regression; Supplementary Fig. 1) between both parameters is depicted. </a:t>
            </a:r>
            <a:endParaRPr lang="he-IL" sz="2400" b="1" dirty="0"/>
          </a:p>
        </p:txBody>
      </p:sp>
      <p:pic>
        <p:nvPicPr>
          <p:cNvPr id="30" name="תמונה 29">
            <a:extLst>
              <a:ext uri="{FF2B5EF4-FFF2-40B4-BE49-F238E27FC236}">
                <a16:creationId xmlns:a16="http://schemas.microsoft.com/office/drawing/2014/main" id="{D7871B67-F983-4A3B-888B-9D13245E08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6854" y="850647"/>
            <a:ext cx="5663675" cy="385300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745E3A5-12EA-4B84-B8A5-D6506F885F8D}"/>
              </a:ext>
            </a:extLst>
          </p:cNvPr>
          <p:cNvSpPr/>
          <p:nvPr/>
        </p:nvSpPr>
        <p:spPr>
          <a:xfrm>
            <a:off x="238141" y="158759"/>
            <a:ext cx="120930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/>
              <a:t>Figure S1 </a:t>
            </a:r>
            <a:endParaRPr lang="en-IL" sz="2000" dirty="0"/>
          </a:p>
        </p:txBody>
      </p:sp>
    </p:spTree>
    <p:extLst>
      <p:ext uri="{BB962C8B-B14F-4D97-AF65-F5344CB8AC3E}">
        <p14:creationId xmlns:p14="http://schemas.microsoft.com/office/powerpoint/2010/main" val="1248740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מלבן 26">
            <a:extLst>
              <a:ext uri="{FF2B5EF4-FFF2-40B4-BE49-F238E27FC236}">
                <a16:creationId xmlns:a16="http://schemas.microsoft.com/office/drawing/2014/main" id="{5F82AB10-AAC3-4A69-9FD0-AC1206CA7B87}"/>
              </a:ext>
            </a:extLst>
          </p:cNvPr>
          <p:cNvSpPr/>
          <p:nvPr/>
        </p:nvSpPr>
        <p:spPr>
          <a:xfrm>
            <a:off x="75221" y="-76319"/>
            <a:ext cx="134338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/>
              <a:t>Figure S2</a:t>
            </a:r>
            <a:endParaRPr lang="he-IL" sz="2400" b="1" dirty="0"/>
          </a:p>
        </p:txBody>
      </p:sp>
      <p:pic>
        <p:nvPicPr>
          <p:cNvPr id="28" name="Picture 4">
            <a:extLst>
              <a:ext uri="{FF2B5EF4-FFF2-40B4-BE49-F238E27FC236}">
                <a16:creationId xmlns:a16="http://schemas.microsoft.com/office/drawing/2014/main" id="{2591C917-95D7-4512-A8A4-180DDDB278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1576996" y="745808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 Box 6">
            <a:extLst>
              <a:ext uri="{FF2B5EF4-FFF2-40B4-BE49-F238E27FC236}">
                <a16:creationId xmlns:a16="http://schemas.microsoft.com/office/drawing/2014/main" id="{B08A9E95-B1F8-4E40-BBFD-291724FA28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6921" y="570389"/>
            <a:ext cx="9144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 rtl="0">
              <a:spcBef>
                <a:spcPct val="50000"/>
              </a:spcBef>
            </a:pPr>
            <a:r>
              <a:rPr lang="en-US" altLang="he-IL" sz="1200" b="1" dirty="0"/>
              <a:t>Ctrl + F4</a:t>
            </a:r>
          </a:p>
        </p:txBody>
      </p:sp>
      <p:sp>
        <p:nvSpPr>
          <p:cNvPr id="30" name="Text Box 7">
            <a:extLst>
              <a:ext uri="{FF2B5EF4-FFF2-40B4-BE49-F238E27FC236}">
                <a16:creationId xmlns:a16="http://schemas.microsoft.com/office/drawing/2014/main" id="{D76F227F-F02C-45C6-BE75-5FD9937069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921" y="875189"/>
            <a:ext cx="533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5%</a:t>
            </a:r>
            <a:br>
              <a:rPr lang="en-US" altLang="he-IL" sz="1200" b="1"/>
            </a:br>
            <a:r>
              <a:rPr lang="en-US" altLang="he-IL" sz="1200" b="1"/>
              <a:t>(85)</a:t>
            </a:r>
          </a:p>
        </p:txBody>
      </p:sp>
      <p:pic>
        <p:nvPicPr>
          <p:cNvPr id="31" name="Picture 10">
            <a:extLst>
              <a:ext uri="{FF2B5EF4-FFF2-40B4-BE49-F238E27FC236}">
                <a16:creationId xmlns:a16="http://schemas.microsoft.com/office/drawing/2014/main" id="{19B8B1AE-D0B3-4A66-9B63-6AF1A03CD2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1576996" y="1997552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 Box 11">
            <a:extLst>
              <a:ext uri="{FF2B5EF4-FFF2-40B4-BE49-F238E27FC236}">
                <a16:creationId xmlns:a16="http://schemas.microsoft.com/office/drawing/2014/main" id="{11E0A9B7-8E91-4C1C-BC0E-5B45D068F06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70571" y="2483327"/>
            <a:ext cx="7620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he-IL" sz="1600" b="1"/>
              <a:t>Ag</a:t>
            </a:r>
            <a:r>
              <a:rPr lang="en-US" altLang="he-IL" sz="1600" b="1" baseline="30000"/>
              <a:t>–</a:t>
            </a:r>
          </a:p>
        </p:txBody>
      </p:sp>
      <p:sp>
        <p:nvSpPr>
          <p:cNvPr id="33" name="Text Box 13">
            <a:extLst>
              <a:ext uri="{FF2B5EF4-FFF2-40B4-BE49-F238E27FC236}">
                <a16:creationId xmlns:a16="http://schemas.microsoft.com/office/drawing/2014/main" id="{08269506-EA21-4598-BD2D-FFD223EC25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921" y="2119789"/>
            <a:ext cx="533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9%</a:t>
            </a:r>
            <a:br>
              <a:rPr lang="en-US" altLang="he-IL" sz="1200" b="1"/>
            </a:br>
            <a:r>
              <a:rPr lang="en-US" altLang="he-IL" sz="1200" b="1"/>
              <a:t>(82)</a:t>
            </a:r>
          </a:p>
        </p:txBody>
      </p:sp>
      <p:pic>
        <p:nvPicPr>
          <p:cNvPr id="34" name="Picture 16">
            <a:extLst>
              <a:ext uri="{FF2B5EF4-FFF2-40B4-BE49-F238E27FC236}">
                <a16:creationId xmlns:a16="http://schemas.microsoft.com/office/drawing/2014/main" id="{86827E87-C690-4C68-808A-9550EB0F74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1561121" y="3262789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Rectangle 18">
            <a:extLst>
              <a:ext uri="{FF2B5EF4-FFF2-40B4-BE49-F238E27FC236}">
                <a16:creationId xmlns:a16="http://schemas.microsoft.com/office/drawing/2014/main" id="{D7B6A26B-A064-46A4-8A91-9FF131CACA6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85947" y="3355657"/>
            <a:ext cx="16700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he-IL" b="1"/>
              <a:t>Exposed to – </a:t>
            </a:r>
          </a:p>
        </p:txBody>
      </p:sp>
      <p:sp>
        <p:nvSpPr>
          <p:cNvPr id="36" name="Text Box 19">
            <a:extLst>
              <a:ext uri="{FF2B5EF4-FFF2-40B4-BE49-F238E27FC236}">
                <a16:creationId xmlns:a16="http://schemas.microsoft.com/office/drawing/2014/main" id="{F3FAAAF3-28BB-45A4-898B-6BA6D78992A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60240" y="1248079"/>
            <a:ext cx="989012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he-IL" sz="1600" b="1"/>
              <a:t>No Target</a:t>
            </a:r>
            <a:endParaRPr lang="en-US" altLang="he-IL" sz="1600" b="1" dirty="0"/>
          </a:p>
        </p:txBody>
      </p:sp>
      <p:pic>
        <p:nvPicPr>
          <p:cNvPr id="37" name="Picture 20">
            <a:extLst>
              <a:ext uri="{FF2B5EF4-FFF2-40B4-BE49-F238E27FC236}">
                <a16:creationId xmlns:a16="http://schemas.microsoft.com/office/drawing/2014/main" id="{AD040A7B-5A1A-42AB-BDFF-5D5F94A37B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1561121" y="4562952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Text Box 22">
            <a:extLst>
              <a:ext uri="{FF2B5EF4-FFF2-40B4-BE49-F238E27FC236}">
                <a16:creationId xmlns:a16="http://schemas.microsoft.com/office/drawing/2014/main" id="{61BEFF91-E5A3-4134-A1B2-5F308B57046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89609" y="3602514"/>
            <a:ext cx="9144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he-IL" sz="1600" b="1" dirty="0"/>
              <a:t>Ag</a:t>
            </a:r>
            <a:r>
              <a:rPr lang="en-US" altLang="he-IL" sz="1600" b="1" baseline="30000" dirty="0"/>
              <a:t>+</a:t>
            </a:r>
          </a:p>
        </p:txBody>
      </p:sp>
      <p:sp>
        <p:nvSpPr>
          <p:cNvPr id="39" name="Text Box 24">
            <a:extLst>
              <a:ext uri="{FF2B5EF4-FFF2-40B4-BE49-F238E27FC236}">
                <a16:creationId xmlns:a16="http://schemas.microsoft.com/office/drawing/2014/main" id="{B3521CED-3DD6-4CB1-80C5-209A41A96B2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99109" y="4936014"/>
            <a:ext cx="12954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he-IL" sz="1600" b="1" dirty="0"/>
              <a:t>Ag+</a:t>
            </a:r>
            <a:r>
              <a:rPr lang="en-US" altLang="he-IL" sz="1600" dirty="0"/>
              <a:t> </a:t>
            </a:r>
            <a:r>
              <a:rPr lang="en-US" altLang="he-IL" sz="1600" b="1" dirty="0"/>
              <a:t>/CD155</a:t>
            </a:r>
          </a:p>
        </p:txBody>
      </p:sp>
      <p:sp>
        <p:nvSpPr>
          <p:cNvPr id="40" name="Text Box 25">
            <a:extLst>
              <a:ext uri="{FF2B5EF4-FFF2-40B4-BE49-F238E27FC236}">
                <a16:creationId xmlns:a16="http://schemas.microsoft.com/office/drawing/2014/main" id="{F8870917-004B-4FD7-A134-0597852086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921" y="3389789"/>
            <a:ext cx="609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32%</a:t>
            </a:r>
            <a:br>
              <a:rPr lang="en-US" altLang="he-IL" sz="1200" b="1"/>
            </a:br>
            <a:r>
              <a:rPr lang="en-US" altLang="he-IL" sz="1200" b="1"/>
              <a:t>(83)</a:t>
            </a:r>
          </a:p>
        </p:txBody>
      </p:sp>
      <p:sp>
        <p:nvSpPr>
          <p:cNvPr id="41" name="Text Box 26">
            <a:extLst>
              <a:ext uri="{FF2B5EF4-FFF2-40B4-BE49-F238E27FC236}">
                <a16:creationId xmlns:a16="http://schemas.microsoft.com/office/drawing/2014/main" id="{B558C79A-7FAE-44D7-8462-967DBDD407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921" y="4685189"/>
            <a:ext cx="609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5%</a:t>
            </a:r>
            <a:br>
              <a:rPr lang="en-US" altLang="he-IL" sz="1200" b="1"/>
            </a:br>
            <a:r>
              <a:rPr lang="en-US" altLang="he-IL" sz="1200" b="1"/>
              <a:t>(80)</a:t>
            </a:r>
          </a:p>
        </p:txBody>
      </p:sp>
      <p:pic>
        <p:nvPicPr>
          <p:cNvPr id="42" name="Picture 27">
            <a:extLst>
              <a:ext uri="{FF2B5EF4-FFF2-40B4-BE49-F238E27FC236}">
                <a16:creationId xmlns:a16="http://schemas.microsoft.com/office/drawing/2014/main" id="{FD2B8E0F-DC43-4FC9-ADFC-53B5422F52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3596296" y="2048352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 Box 28">
            <a:extLst>
              <a:ext uri="{FF2B5EF4-FFF2-40B4-BE49-F238E27FC236}">
                <a16:creationId xmlns:a16="http://schemas.microsoft.com/office/drawing/2014/main" id="{2932CC53-07F1-4B22-BEB6-5A5EE98D2E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6321" y="2170589"/>
            <a:ext cx="533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9%</a:t>
            </a:r>
            <a:br>
              <a:rPr lang="en-US" altLang="he-IL" sz="1200" b="1"/>
            </a:br>
            <a:r>
              <a:rPr lang="en-US" altLang="he-IL" sz="1200" b="1"/>
              <a:t>(83)</a:t>
            </a:r>
          </a:p>
        </p:txBody>
      </p:sp>
      <p:pic>
        <p:nvPicPr>
          <p:cNvPr id="44" name="Picture 29">
            <a:extLst>
              <a:ext uri="{FF2B5EF4-FFF2-40B4-BE49-F238E27FC236}">
                <a16:creationId xmlns:a16="http://schemas.microsoft.com/office/drawing/2014/main" id="{F3DEBAA0-BFBE-4838-A40F-10239A95F3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3596296" y="3313589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 Box 30">
            <a:extLst>
              <a:ext uri="{FF2B5EF4-FFF2-40B4-BE49-F238E27FC236}">
                <a16:creationId xmlns:a16="http://schemas.microsoft.com/office/drawing/2014/main" id="{7BB51E59-6387-4340-B22C-0CB71EA167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6321" y="3465989"/>
            <a:ext cx="533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9%</a:t>
            </a:r>
            <a:br>
              <a:rPr lang="en-US" altLang="he-IL" sz="1200" b="1"/>
            </a:br>
            <a:r>
              <a:rPr lang="en-US" altLang="he-IL" sz="1200" b="1"/>
              <a:t>(83)</a:t>
            </a:r>
          </a:p>
        </p:txBody>
      </p:sp>
      <p:pic>
        <p:nvPicPr>
          <p:cNvPr id="46" name="Picture 32">
            <a:extLst>
              <a:ext uri="{FF2B5EF4-FFF2-40B4-BE49-F238E27FC236}">
                <a16:creationId xmlns:a16="http://schemas.microsoft.com/office/drawing/2014/main" id="{12A0ECF0-2DD2-4046-AF39-923B157988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3596296" y="4608989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 Box 33">
            <a:extLst>
              <a:ext uri="{FF2B5EF4-FFF2-40B4-BE49-F238E27FC236}">
                <a16:creationId xmlns:a16="http://schemas.microsoft.com/office/drawing/2014/main" id="{17C87865-B4A6-4FC3-A8D1-9E270FD8E6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6321" y="4685189"/>
            <a:ext cx="609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6%</a:t>
            </a:r>
            <a:br>
              <a:rPr lang="en-US" altLang="he-IL" sz="1200" b="1"/>
            </a:br>
            <a:r>
              <a:rPr lang="en-US" altLang="he-IL" sz="1200" b="1"/>
              <a:t>(82)</a:t>
            </a:r>
          </a:p>
        </p:txBody>
      </p:sp>
      <p:sp>
        <p:nvSpPr>
          <p:cNvPr id="48" name="Line 34">
            <a:extLst>
              <a:ext uri="{FF2B5EF4-FFF2-40B4-BE49-F238E27FC236}">
                <a16:creationId xmlns:a16="http://schemas.microsoft.com/office/drawing/2014/main" id="{79FA8698-2D59-4384-91FC-DF9C108C1DAB}"/>
              </a:ext>
            </a:extLst>
          </p:cNvPr>
          <p:cNvSpPr>
            <a:spLocks noChangeShapeType="1"/>
          </p:cNvSpPr>
          <p:nvPr/>
        </p:nvSpPr>
        <p:spPr bwMode="auto">
          <a:xfrm>
            <a:off x="1507146" y="5949991"/>
            <a:ext cx="4267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he-IL"/>
          </a:p>
        </p:txBody>
      </p:sp>
      <p:sp>
        <p:nvSpPr>
          <p:cNvPr id="49" name="Text Box 35">
            <a:extLst>
              <a:ext uri="{FF2B5EF4-FFF2-40B4-BE49-F238E27FC236}">
                <a16:creationId xmlns:a16="http://schemas.microsoft.com/office/drawing/2014/main" id="{181B9425-2967-4216-BC36-D42ED18BBE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5296" y="5980589"/>
            <a:ext cx="76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he-IL" sz="1400" b="1" dirty="0"/>
              <a:t>V</a:t>
            </a:r>
            <a:r>
              <a:rPr lang="el-GR" altLang="he-IL" sz="1400" b="1" dirty="0">
                <a:cs typeface="Arial" panose="020B0604020202020204" pitchFamily="34" charset="0"/>
              </a:rPr>
              <a:t>β</a:t>
            </a:r>
            <a:r>
              <a:rPr lang="en-US" altLang="he-IL" sz="1400" b="1" dirty="0"/>
              <a:t>12</a:t>
            </a:r>
          </a:p>
        </p:txBody>
      </p:sp>
      <p:pic>
        <p:nvPicPr>
          <p:cNvPr id="50" name="Picture 37">
            <a:extLst>
              <a:ext uri="{FF2B5EF4-FFF2-40B4-BE49-F238E27FC236}">
                <a16:creationId xmlns:a16="http://schemas.microsoft.com/office/drawing/2014/main" id="{E683E225-67B9-4486-AE85-378DB4F141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11293" b="11293"/>
          <a:stretch>
            <a:fillRect/>
          </a:stretch>
        </p:blipFill>
        <p:spPr bwMode="auto">
          <a:xfrm>
            <a:off x="3596296" y="764064"/>
            <a:ext cx="2079625" cy="125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Text Box 38">
            <a:extLst>
              <a:ext uri="{FF2B5EF4-FFF2-40B4-BE49-F238E27FC236}">
                <a16:creationId xmlns:a16="http://schemas.microsoft.com/office/drawing/2014/main" id="{EDC1C5C3-AD8F-4535-9996-80A618E0FB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0857" y="570389"/>
            <a:ext cx="14478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 rtl="0">
              <a:spcBef>
                <a:spcPct val="50000"/>
              </a:spcBef>
            </a:pPr>
            <a:r>
              <a:rPr lang="en-US" altLang="he-IL" sz="1200" b="1" dirty="0"/>
              <a:t>TIGIT-28 + F4</a:t>
            </a:r>
          </a:p>
        </p:txBody>
      </p:sp>
      <p:sp>
        <p:nvSpPr>
          <p:cNvPr id="52" name="Text Box 39">
            <a:extLst>
              <a:ext uri="{FF2B5EF4-FFF2-40B4-BE49-F238E27FC236}">
                <a16:creationId xmlns:a16="http://schemas.microsoft.com/office/drawing/2014/main" id="{4D5A9DB3-AEF7-4BC1-8076-4762B85A4F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8221" y="875189"/>
            <a:ext cx="533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he-IL" sz="1200" b="1"/>
              <a:t>22%</a:t>
            </a:r>
            <a:br>
              <a:rPr lang="en-US" altLang="he-IL" sz="1200" b="1"/>
            </a:br>
            <a:r>
              <a:rPr lang="en-US" altLang="he-IL" sz="1200" b="1"/>
              <a:t>(83)</a:t>
            </a:r>
          </a:p>
        </p:txBody>
      </p:sp>
      <p:sp>
        <p:nvSpPr>
          <p:cNvPr id="53" name="מלבן 26">
            <a:extLst>
              <a:ext uri="{FF2B5EF4-FFF2-40B4-BE49-F238E27FC236}">
                <a16:creationId xmlns:a16="http://schemas.microsoft.com/office/drawing/2014/main" id="{CEC84D17-C116-444F-BCDE-3A33269E11EA}"/>
              </a:ext>
            </a:extLst>
          </p:cNvPr>
          <p:cNvSpPr/>
          <p:nvPr/>
        </p:nvSpPr>
        <p:spPr>
          <a:xfrm>
            <a:off x="6188193" y="707708"/>
            <a:ext cx="5584706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2000" b="1" dirty="0"/>
              <a:t>Figure S2: </a:t>
            </a:r>
            <a:r>
              <a:rPr lang="en-US" sz="2000" dirty="0"/>
              <a:t>F4 TCR expression was determined by flow cytometry in T-cells that were subjected for 8 days to antigen negative (Ag-; HeLa), antigen positive (Ag</a:t>
            </a:r>
            <a:r>
              <a:rPr lang="en-US" sz="2000" baseline="30000" dirty="0"/>
              <a:t>+</a:t>
            </a:r>
            <a:r>
              <a:rPr lang="en-US" sz="2000" dirty="0"/>
              <a:t>;888A2), antigen positive transduced with CD155 (Ag</a:t>
            </a:r>
            <a:r>
              <a:rPr lang="en-US" sz="2000" baseline="30000" dirty="0"/>
              <a:t>+</a:t>
            </a:r>
            <a:r>
              <a:rPr lang="en-US" sz="2000" dirty="0"/>
              <a:t>;888A2/CD155) or no target (No T) and then rested for 6-8 hours in lymphocyte medium. The percentage of positive cells and the MFI (in brackets) are shown.</a:t>
            </a:r>
            <a:endParaRPr lang="he-IL" sz="2000" dirty="0"/>
          </a:p>
        </p:txBody>
      </p:sp>
    </p:spTree>
    <p:extLst>
      <p:ext uri="{BB962C8B-B14F-4D97-AF65-F5344CB8AC3E}">
        <p14:creationId xmlns:p14="http://schemas.microsoft.com/office/powerpoint/2010/main" val="3336568481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1</TotalTime>
  <Words>195</Words>
  <Application>Microsoft Office PowerPoint</Application>
  <PresentationFormat>Widescreen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ערכת נושא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שירן חוגי</dc:creator>
  <cp:lastModifiedBy>Cyrille Cohen</cp:lastModifiedBy>
  <cp:revision>213</cp:revision>
  <dcterms:created xsi:type="dcterms:W3CDTF">2019-05-04T10:21:18Z</dcterms:created>
  <dcterms:modified xsi:type="dcterms:W3CDTF">2019-07-21T08:08:42Z</dcterms:modified>
</cp:coreProperties>
</file>